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9.png" ContentType="image/png"/>
  <Override PartName="/ppt/media/image14.png" ContentType="image/png"/>
  <Override PartName="/ppt/media/image1.png" ContentType="image/png"/>
  <Override PartName="/ppt/media/image3.jpeg" ContentType="image/jpeg"/>
  <Override PartName="/ppt/media/image2.wmf" ContentType="image/x-wmf"/>
  <Override PartName="/ppt/media/image4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979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74337-BEE4-4DBA-9DFC-396709F994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746748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1371240" y="4220640"/>
            <a:ext cx="746748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E9ACE-876E-4F43-A8E9-C076FB2E75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8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9" name="PlaceHolder 4"/>
          <p:cNvSpPr>
            <a:spLocks noGrp="1"/>
          </p:cNvSpPr>
          <p:nvPr>
            <p:ph/>
          </p:nvPr>
        </p:nvSpPr>
        <p:spPr>
          <a:xfrm>
            <a:off x="137124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0" name="PlaceHolder 5"/>
          <p:cNvSpPr>
            <a:spLocks noGrp="1"/>
          </p:cNvSpPr>
          <p:nvPr>
            <p:ph/>
          </p:nvPr>
        </p:nvSpPr>
        <p:spPr>
          <a:xfrm>
            <a:off x="519768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4E8B7-E6C8-4F5C-A04A-4E1EDEB06C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/>
          </p:nvPr>
        </p:nvSpPr>
        <p:spPr>
          <a:xfrm>
            <a:off x="3896280" y="175248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/>
          </p:nvPr>
        </p:nvSpPr>
        <p:spPr>
          <a:xfrm>
            <a:off x="6421320" y="175248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/>
          </p:nvPr>
        </p:nvSpPr>
        <p:spPr>
          <a:xfrm>
            <a:off x="1371240" y="422064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6" name="PlaceHolder 6"/>
          <p:cNvSpPr>
            <a:spLocks noGrp="1"/>
          </p:cNvSpPr>
          <p:nvPr>
            <p:ph/>
          </p:nvPr>
        </p:nvSpPr>
        <p:spPr>
          <a:xfrm>
            <a:off x="3896280" y="422064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7" name="PlaceHolder 7"/>
          <p:cNvSpPr>
            <a:spLocks noGrp="1"/>
          </p:cNvSpPr>
          <p:nvPr>
            <p:ph/>
          </p:nvPr>
        </p:nvSpPr>
        <p:spPr>
          <a:xfrm>
            <a:off x="6421320" y="422064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9BB4B-FCE8-4913-9A94-E806456DFF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6FE05A0-9C03-4592-A323-A4BB09DB10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subTitle"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3152118-F64F-4614-B8DD-A45673E18D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75DB65-331C-47D0-8CA0-0CCCACA245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7F84C92-4550-4043-8298-715CE9DCBF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753006-74F1-4A3C-8D10-A7C8B30B51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ubTitle"/>
          </p:nvPr>
        </p:nvSpPr>
        <p:spPr>
          <a:xfrm>
            <a:off x="1219320" y="533520"/>
            <a:ext cx="7772400" cy="353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115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660760-FED6-4782-9E7E-BEB66EB0DE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137124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543A0C2-EE7C-4C09-B7D1-A3E25795B8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subTitle"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4EF32-AE11-46C8-8AB7-734944473C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519768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D354952-3E7D-43D2-995D-EB70EFCB9B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1371240" y="4220640"/>
            <a:ext cx="746748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CC6BB3-C110-4284-9B63-B1443EE8B9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746748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1371240" y="4220640"/>
            <a:ext cx="746748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0D214DA-9963-4123-A16B-0CE2DCEBF5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/>
          </p:nvPr>
        </p:nvSpPr>
        <p:spPr>
          <a:xfrm>
            <a:off x="137124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2" name="PlaceHolder 5"/>
          <p:cNvSpPr>
            <a:spLocks noGrp="1"/>
          </p:cNvSpPr>
          <p:nvPr>
            <p:ph/>
          </p:nvPr>
        </p:nvSpPr>
        <p:spPr>
          <a:xfrm>
            <a:off x="519768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3FF4ADD-E909-4492-9CAA-06C7EEB8B1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5" name="PlaceHolder 3"/>
          <p:cNvSpPr>
            <a:spLocks noGrp="1"/>
          </p:cNvSpPr>
          <p:nvPr>
            <p:ph/>
          </p:nvPr>
        </p:nvSpPr>
        <p:spPr>
          <a:xfrm>
            <a:off x="3896280" y="175248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6" name="PlaceHolder 4"/>
          <p:cNvSpPr>
            <a:spLocks noGrp="1"/>
          </p:cNvSpPr>
          <p:nvPr>
            <p:ph/>
          </p:nvPr>
        </p:nvSpPr>
        <p:spPr>
          <a:xfrm>
            <a:off x="6421320" y="175248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7" name="PlaceHolder 5"/>
          <p:cNvSpPr>
            <a:spLocks noGrp="1"/>
          </p:cNvSpPr>
          <p:nvPr>
            <p:ph/>
          </p:nvPr>
        </p:nvSpPr>
        <p:spPr>
          <a:xfrm>
            <a:off x="1371240" y="422064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8" name="PlaceHolder 6"/>
          <p:cNvSpPr>
            <a:spLocks noGrp="1"/>
          </p:cNvSpPr>
          <p:nvPr>
            <p:ph/>
          </p:nvPr>
        </p:nvSpPr>
        <p:spPr>
          <a:xfrm>
            <a:off x="3896280" y="422064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9" name="PlaceHolder 7"/>
          <p:cNvSpPr>
            <a:spLocks noGrp="1"/>
          </p:cNvSpPr>
          <p:nvPr>
            <p:ph/>
          </p:nvPr>
        </p:nvSpPr>
        <p:spPr>
          <a:xfrm>
            <a:off x="6421320" y="4220640"/>
            <a:ext cx="240444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ACF645C-FEEE-4B5B-A54F-5335A3D2D4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E384A-7522-4B8F-A744-C320601A8C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D91BB-E6A4-48E6-AE8B-E216A08D94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FE69D-18A9-4952-BB07-A3CDCEBA0E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subTitle"/>
          </p:nvPr>
        </p:nvSpPr>
        <p:spPr>
          <a:xfrm>
            <a:off x="1219320" y="533520"/>
            <a:ext cx="7772400" cy="353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115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9A316-55E0-43EE-ACE8-631D0F94F7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137124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58A4C-E120-44DB-B2F2-7A1B98D04C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5197680" y="422064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59836-942C-465D-98CB-48DB54F7A3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97680" y="1752480"/>
            <a:ext cx="364392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71240" y="4220640"/>
            <a:ext cx="7467480" cy="225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15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11DA3-F31D-48CE-B9CA-5F4CA06B5C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slideLayout" Target="../slideLayouts/slideLayout1.xml"/><Relationship Id="rId10" Type="http://schemas.openxmlformats.org/officeDocument/2006/relationships/slideLayout" Target="../slideLayouts/slideLayout2.xml"/><Relationship Id="rId11" Type="http://schemas.openxmlformats.org/officeDocument/2006/relationships/slideLayout" Target="../slideLayouts/slideLayout3.xml"/><Relationship Id="rId12" Type="http://schemas.openxmlformats.org/officeDocument/2006/relationships/slideLayout" Target="../slideLayouts/slideLayout4.xml"/><Relationship Id="rId13" Type="http://schemas.openxmlformats.org/officeDocument/2006/relationships/slideLayout" Target="../slideLayouts/slideLayout5.xml"/><Relationship Id="rId14" Type="http://schemas.openxmlformats.org/officeDocument/2006/relationships/slideLayout" Target="../slideLayouts/slideLayout6.xml"/><Relationship Id="rId15" Type="http://schemas.openxmlformats.org/officeDocument/2006/relationships/slideLayout" Target="../slideLayouts/slideLayout7.xml"/><Relationship Id="rId16" Type="http://schemas.openxmlformats.org/officeDocument/2006/relationships/slideLayout" Target="../slideLayouts/slideLayout8.xml"/><Relationship Id="rId17" Type="http://schemas.openxmlformats.org/officeDocument/2006/relationships/slideLayout" Target="../slideLayouts/slideLayout9.xml"/><Relationship Id="rId18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1.xml"/><Relationship Id="rId20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>
            <a:off x="1066680" y="0"/>
            <a:ext cx="8077320" cy="609480"/>
          </a:xfrm>
          <a:prstGeom prst="rect">
            <a:avLst/>
          </a:prstGeom>
          <a:gradFill rotWithShape="0">
            <a:gsLst>
              <a:gs pos="0">
                <a:srgbClr val="7c2022"/>
              </a:gs>
              <a:gs pos="100000">
                <a:srgbClr val="000000"/>
              </a:gs>
            </a:gsLst>
            <a:lin ang="10800000"/>
          </a:gra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" name=""/>
          <p:cNvSpPr/>
          <p:nvPr/>
        </p:nvSpPr>
        <p:spPr>
          <a:xfrm>
            <a:off x="1066680" y="609480"/>
            <a:ext cx="8077320" cy="6248520"/>
          </a:xfrm>
          <a:prstGeom prst="rect">
            <a:avLst/>
          </a:prstGeom>
          <a:gradFill rotWithShape="0">
            <a:gsLst>
              <a:gs pos="0">
                <a:srgbClr val="7c2022"/>
              </a:gs>
              <a:gs pos="50000">
                <a:srgbClr val="000000"/>
              </a:gs>
              <a:gs pos="100000">
                <a:srgbClr val="7c2022"/>
              </a:gs>
            </a:gsLst>
            <a:lin ang="13500000"/>
          </a:gra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0" y="600120"/>
            <a:ext cx="1066680" cy="625788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7c2022"/>
              </a:gs>
            </a:gsLst>
            <a:lin ang="5400000"/>
          </a:gra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1152360" y="676440"/>
            <a:ext cx="7907400" cy="5952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"/>
          <p:cNvSpPr/>
          <p:nvPr/>
        </p:nvSpPr>
        <p:spPr>
          <a:xfrm>
            <a:off x="0" y="0"/>
            <a:ext cx="1066680" cy="609480"/>
          </a:xfrm>
          <a:prstGeom prst="rect">
            <a:avLst/>
          </a:prstGeom>
          <a:solidFill>
            <a:srgbClr val="7c2022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"/>
          <p:cNvSpPr/>
          <p:nvPr/>
        </p:nvSpPr>
        <p:spPr>
          <a:xfrm>
            <a:off x="1162080" y="685800"/>
            <a:ext cx="7888320" cy="45720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Click to edit the outline text format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1" marL="743040" indent="-28584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Second Outline Level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2" marL="1143000" indent="-22860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4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Third Outline Level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3" marL="1600200" indent="-22860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5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Fourth Outline Level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4" marL="2057400" indent="-22860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6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Fifth Outline Level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5" marL="2057400" indent="-22860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7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Sixth Outline Level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6" marL="2057400" indent="-22860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8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Seventh Outline Level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dt" idx="1"/>
          </p:nvPr>
        </p:nvSpPr>
        <p:spPr>
          <a:xfrm>
            <a:off x="1218960" y="659124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4"/>
          <p:cNvSpPr>
            <a:spLocks noGrp="1"/>
          </p:cNvSpPr>
          <p:nvPr>
            <p:ph type="ftr" idx="2"/>
          </p:nvPr>
        </p:nvSpPr>
        <p:spPr>
          <a:xfrm>
            <a:off x="3505320" y="6629400"/>
            <a:ext cx="32004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5"/>
          <p:cNvSpPr>
            <a:spLocks noGrp="1"/>
          </p:cNvSpPr>
          <p:nvPr>
            <p:ph type="sldNum" idx="3"/>
          </p:nvPr>
        </p:nvSpPr>
        <p:spPr>
          <a:xfrm>
            <a:off x="7086600" y="659124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CFC818-C632-4F5C-B5B6-A7FFC4619840}" type="slidenum">
              <a:rPr b="0" lang="en-US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Base" hidden="1"/>
          <p:cNvSpPr/>
          <p:nvPr/>
        </p:nvSpPr>
        <p:spPr>
          <a:xfrm>
            <a:off x="1523880" y="1397160"/>
            <a:ext cx="6096240" cy="40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9"/>
    <p:sldLayoutId id="2147483650" r:id="rId10"/>
    <p:sldLayoutId id="2147483651" r:id="rId11"/>
    <p:sldLayoutId id="2147483652" r:id="rId12"/>
    <p:sldLayoutId id="2147483653" r:id="rId13"/>
    <p:sldLayoutId id="2147483654" r:id="rId14"/>
    <p:sldLayoutId id="2147483655" r:id="rId15"/>
    <p:sldLayoutId id="2147483656" r:id="rId16"/>
    <p:sldLayoutId id="2147483657" r:id="rId17"/>
    <p:sldLayoutId id="2147483658" r:id="rId18"/>
    <p:sldLayoutId id="2147483659" r:id="rId19"/>
    <p:sldLayoutId id="2147483660" r:id="rId20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1066680" y="0"/>
            <a:ext cx="8077320" cy="609480"/>
          </a:xfrm>
          <a:prstGeom prst="rect">
            <a:avLst/>
          </a:prstGeom>
          <a:gradFill rotWithShape="0">
            <a:gsLst>
              <a:gs pos="0">
                <a:srgbClr val="7c2022"/>
              </a:gs>
              <a:gs pos="100000">
                <a:srgbClr val="000000"/>
              </a:gs>
            </a:gsLst>
            <a:lin ang="10800000"/>
          </a:gra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066680" y="609480"/>
            <a:ext cx="8077320" cy="6248520"/>
          </a:xfrm>
          <a:prstGeom prst="rect">
            <a:avLst/>
          </a:prstGeom>
          <a:gradFill rotWithShape="0">
            <a:gsLst>
              <a:gs pos="0">
                <a:srgbClr val="7c2022"/>
              </a:gs>
              <a:gs pos="50000">
                <a:srgbClr val="000000"/>
              </a:gs>
              <a:gs pos="100000">
                <a:srgbClr val="7c2022"/>
              </a:gs>
            </a:gsLst>
            <a:lin ang="13500000"/>
          </a:gra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0" y="600120"/>
            <a:ext cx="1066680" cy="625788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7c2022"/>
              </a:gs>
            </a:gsLst>
            <a:lin ang="5400000"/>
          </a:gra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0" y="5029200"/>
            <a:ext cx="1066680" cy="1066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0" y="5553000"/>
            <a:ext cx="1066680" cy="1295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53" name="" descr=""/>
          <p:cNvPicPr/>
          <p:nvPr/>
        </p:nvPicPr>
        <p:blipFill>
          <a:blip r:embed="rId2"/>
          <a:stretch/>
        </p:blipFill>
        <p:spPr>
          <a:xfrm>
            <a:off x="114480" y="5391000"/>
            <a:ext cx="838080" cy="55116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1152360" y="676440"/>
            <a:ext cx="7907400" cy="5952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0" y="0"/>
            <a:ext cx="1066680" cy="609480"/>
          </a:xfrm>
          <a:prstGeom prst="rect">
            <a:avLst/>
          </a:prstGeom>
          <a:solidFill>
            <a:srgbClr val="7c2022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162080" y="685800"/>
            <a:ext cx="7888320" cy="45720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162080" y="685800"/>
            <a:ext cx="2057400" cy="160020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1162080" y="1162080"/>
            <a:ext cx="4019400" cy="249552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Click to edit Master title style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37160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Click to edit Master text styles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Second level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Third level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Fourth level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Fifth level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dt" idx="4"/>
          </p:nvPr>
        </p:nvSpPr>
        <p:spPr>
          <a:xfrm>
            <a:off x="1218960" y="659124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ftr" idx="5"/>
          </p:nvPr>
        </p:nvSpPr>
        <p:spPr>
          <a:xfrm>
            <a:off x="3657240" y="659124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sldNum" idx="6"/>
          </p:nvPr>
        </p:nvSpPr>
        <p:spPr>
          <a:xfrm>
            <a:off x="7086600" y="659124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4F45F1-4783-4738-864D-25BE4B6832F2}" type="slidenum"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hyperlink" Target="https://cissecure.nci.nih.gov/ncipubs/" TargetMode="External"/><Relationship Id="rId4" Type="http://schemas.openxmlformats.org/officeDocument/2006/relationships/hyperlink" Target="https://cissecure.nci.nih.gov/ncipubs/" TargetMode="External"/><Relationship Id="rId5" Type="http://schemas.openxmlformats.org/officeDocument/2006/relationships/hyperlink" Target="https://cissecure.nci.nih.gov/ncipubs/" TargetMode="External"/><Relationship Id="rId6" Type="http://schemas.openxmlformats.org/officeDocument/2006/relationships/image" Target="../media/image1.png"/><Relationship Id="rId7" Type="http://schemas.openxmlformats.org/officeDocument/2006/relationships/hyperlink" Target="http://www.cancer.gov/cancerinfo/wyntk/lung" TargetMode="External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hyperlink" Target="http://www.medicomdigital.com/nci/lungcancer" TargetMode="External"/><Relationship Id="rId11" Type="http://schemas.openxmlformats.org/officeDocument/2006/relationships/image" Target="../media/image1.png"/><Relationship Id="rId12" Type="http://schemas.openxmlformats.org/officeDocument/2006/relationships/hyperlink" Target="http://www.audible.com/nci" TargetMode="External"/><Relationship Id="rId13" Type="http://schemas.openxmlformats.org/officeDocument/2006/relationships/image" Target="../media/image1.png"/><Relationship Id="rId14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hyperlink" Target="http://www.medicomdigital.com/nci/lungcancer" TargetMode="External"/><Relationship Id="rId3" Type="http://schemas.openxmlformats.org/officeDocument/2006/relationships/hyperlink" Target="http://www.medicomdigital.com/nci/lungcancer" TargetMode="External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hyperlink" Target="http://www.audible.com/nci" TargetMode="External"/><Relationship Id="rId6" Type="http://schemas.openxmlformats.org/officeDocument/2006/relationships/hyperlink" Target="http://www.audible.com/nci" TargetMode="External"/><Relationship Id="rId7" Type="http://schemas.openxmlformats.org/officeDocument/2006/relationships/slideLayout" Target="../slideLayouts/slideLayout1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3.jpeg"/><Relationship Id="rId3" Type="http://schemas.openxmlformats.org/officeDocument/2006/relationships/hyperlink" Target="https://cissecure.nci.nih.gov/ncipubs/" TargetMode="External"/><Relationship Id="rId4" Type="http://schemas.openxmlformats.org/officeDocument/2006/relationships/hyperlink" Target="https://cissecure.nci.nih.gov/ncipubs/" TargetMode="External"/><Relationship Id="rId5" Type="http://schemas.openxmlformats.org/officeDocument/2006/relationships/hyperlink" Target="https://cissecure.nci.nih.gov/ncipubs/" TargetMode="External"/><Relationship Id="rId6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hyperlink" Target="http://www.cancer.gov/cancerinfo/wyntk/lung" TargetMode="External"/><Relationship Id="rId3" Type="http://schemas.openxmlformats.org/officeDocument/2006/relationships/hyperlink" Target="http://www.cancer.gov/cancerinfo/wyntk/lung" TargetMode="External"/><Relationship Id="rId4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hyperlink" Target="http://www.medicomdigital.com/nci/lungcancer/start.html" TargetMode="External"/><Relationship Id="rId2" Type="http://schemas.openxmlformats.org/officeDocument/2006/relationships/image" Target="../media/image6.png"/><Relationship Id="rId3" Type="http://schemas.openxmlformats.org/officeDocument/2006/relationships/hyperlink" Target="http://www.medicomdigital.com/nci/lungcancer" TargetMode="External"/><Relationship Id="rId4" Type="http://schemas.openxmlformats.org/officeDocument/2006/relationships/hyperlink" Target="http://www.medicomdigital.com/nci/lungcancer" TargetMode="External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hyperlink" Target="http://www.medicomdigital.com/nci/lungcancer" TargetMode="External"/><Relationship Id="rId3" Type="http://schemas.openxmlformats.org/officeDocument/2006/relationships/hyperlink" Target="http://www.medicomdigital.com/nci/lungcancer" TargetMode="External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hyperlink" Target="http://www.medicomdigital.com/nci/lungcancer" TargetMode="External"/><Relationship Id="rId3" Type="http://schemas.openxmlformats.org/officeDocument/2006/relationships/hyperlink" Target="http://www.medicomdigital.com/nci/lungcancer" TargetMode="External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hyperlink" Target="http://www.medicomdigital.com/nci/lungcancer" TargetMode="External"/><Relationship Id="rId3" Type="http://schemas.openxmlformats.org/officeDocument/2006/relationships/hyperlink" Target="http://www.medicomdigital.com/nci/lungcancer" TargetMode="External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 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Demo 5 Media Formats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2 existing text formats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1" marL="743040" indent="-28584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c2022"/>
                </a:solidFill>
                <a:latin typeface="Arial"/>
                <a:ea typeface="Arial"/>
              </a:rPr>
              <a:t>Paper: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 paperback booklet can be ordered free online </a:t>
            </a:r>
            <a:r>
              <a:rPr b="1" lang="en-US" sz="2000" spc="-1" strike="noStrike" u="sng">
                <a:solidFill>
                  <a:srgbClr val="0b3d91"/>
                </a:solidFill>
                <a:uFillTx/>
                <a:latin typeface="Arial"/>
                <a:ea typeface="Arial"/>
                <a:hlinkClick r:id="rId3"/>
              </a:rPr>
              <a:t>https://</a:t>
            </a:r>
            <a:r>
              <a:rPr b="1" lang="en-US" sz="2000" spc="-1" strike="noStrike" u="sng">
                <a:solidFill>
                  <a:srgbClr val="0b3d91"/>
                </a:solidFill>
                <a:uFillTx/>
                <a:latin typeface="Arial"/>
                <a:ea typeface="Arial"/>
                <a:hlinkClick r:id="rId4"/>
              </a:rPr>
              <a:t>cissecure.nci.nih.gov/ncipubs</a:t>
            </a:r>
            <a:r>
              <a:rPr b="1" lang="en-US" sz="2000" spc="-1" strike="noStrike" u="sng">
                <a:solidFill>
                  <a:srgbClr val="0b3d91"/>
                </a:solidFill>
                <a:uFillTx/>
                <a:latin typeface="Arial"/>
                <a:ea typeface="Arial"/>
                <a:hlinkClick r:id="rId5"/>
              </a:rPr>
              <a:t>/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1" marL="743040" indent="-28584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6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c2022"/>
                </a:solidFill>
                <a:latin typeface="Arial"/>
                <a:ea typeface="Arial"/>
              </a:rPr>
              <a:t>Web: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        </a:t>
            </a:r>
            <a:r>
              <a:rPr b="1" lang="en-US" sz="2000" spc="-1" strike="noStrike" u="sng">
                <a:solidFill>
                  <a:srgbClr val="0b3d91"/>
                </a:solidFill>
                <a:uFillTx/>
                <a:latin typeface="Arial"/>
                <a:ea typeface="Arial"/>
                <a:hlinkClick r:id="rId7"/>
              </a:rPr>
              <a:t>http://www.cancer.gov/cancerinfo/wyntk/lung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 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marL="343080" indent="-34308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8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3 new formats created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1" marL="743040" indent="-28584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9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c2022"/>
                </a:solidFill>
                <a:latin typeface="Arial"/>
                <a:ea typeface="Arial"/>
              </a:rPr>
              <a:t>Flash™: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 </a:t>
            </a:r>
            <a:r>
              <a:rPr b="1" lang="en-US" sz="2000" spc="-1" strike="noStrike" u="sng">
                <a:solidFill>
                  <a:srgbClr val="0b3d91"/>
                </a:solidFill>
                <a:uFillTx/>
                <a:latin typeface="Arial"/>
                <a:ea typeface="Arial"/>
                <a:hlinkClick r:id="rId10"/>
              </a:rPr>
              <a:t>animation loops, graphics, audio, dictionary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1" marL="743040" indent="-28584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1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c2022"/>
                </a:solidFill>
                <a:latin typeface="Arial"/>
                <a:ea typeface="Arial"/>
              </a:rPr>
              <a:t>Audio: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 </a:t>
            </a:r>
            <a:r>
              <a:rPr b="1" lang="en-US" sz="2000" spc="-1" strike="noStrike" u="sng">
                <a:solidFill>
                  <a:srgbClr val="0b3d91"/>
                </a:solidFill>
                <a:uFillTx/>
                <a:latin typeface="Arial"/>
                <a:ea typeface="Arial"/>
                <a:hlinkClick r:id="rId12"/>
              </a:rPr>
              <a:t>spoken audio program downloaded to PC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  <a:p>
            <a:pPr lvl="1" marL="743040" indent="-28584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13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7c2022"/>
                </a:solidFill>
                <a:latin typeface="Arial"/>
                <a:ea typeface="Arial"/>
              </a:rPr>
              <a:t>Audio + web: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 synchronized spoken audio + web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133720" y="5105520"/>
            <a:ext cx="5638680" cy="9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3352680" y="5486400"/>
            <a:ext cx="2743200" cy="96696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Identical Transcript</a:t>
            </a:r>
            <a:r>
              <a:rPr b="1" lang="en-US" sz="1800" spc="-1" strike="noStrike">
                <a:solidFill>
                  <a:srgbClr val="0b3d91"/>
                </a:solidFill>
                <a:latin typeface="Arial"/>
              </a:rPr>
              <a:t> </a:t>
            </a:r>
            <a:br>
              <a:rPr sz="1800"/>
            </a:br>
            <a:r>
              <a:rPr b="1" lang="en-US" sz="1800" spc="-1" strike="noStrike">
                <a:solidFill>
                  <a:srgbClr val="0b3d91"/>
                </a:solidFill>
                <a:latin typeface="Arial"/>
              </a:rPr>
              <a:t>in all 5 formats </a:t>
            </a:r>
            <a:br>
              <a:rPr sz="1800"/>
            </a:br>
            <a:r>
              <a:rPr b="1" lang="en-US" sz="1800" spc="-1" strike="noStrike">
                <a:solidFill>
                  <a:srgbClr val="0b3d91"/>
                </a:solidFill>
                <a:latin typeface="Arial"/>
              </a:rPr>
              <a:t>(word for word)</a:t>
            </a:r>
            <a:r>
              <a:rPr b="1" lang="en-US" sz="1900" spc="-1" strike="noStrike">
                <a:solidFill>
                  <a:srgbClr val="0b3d91"/>
                </a:solidFill>
                <a:latin typeface="Times New Roman"/>
              </a:rPr>
              <a:t> 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C920B-D55E-4067-A571-1B42D2CA8C93}" type="slidenum">
              <a:t>1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Select Dictionary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58" name="" descr=""/>
          <p:cNvPicPr/>
          <p:nvPr/>
        </p:nvPicPr>
        <p:blipFill>
          <a:blip r:embed="rId1"/>
          <a:stretch/>
        </p:blipFill>
        <p:spPr>
          <a:xfrm>
            <a:off x="1828800" y="1447920"/>
            <a:ext cx="6537240" cy="4724280"/>
          </a:xfrm>
          <a:prstGeom prst="rect">
            <a:avLst/>
          </a:prstGeom>
          <a:ln w="0">
            <a:noFill/>
          </a:ln>
        </p:spPr>
      </p:pic>
      <p:sp>
        <p:nvSpPr>
          <p:cNvPr id="159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900" spc="-1" strike="noStrike">
                <a:solidFill>
                  <a:srgbClr val="0b3d91"/>
                </a:solidFill>
                <a:latin typeface="Arial"/>
              </a:rPr>
              <a:t>http://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 flipH="1">
            <a:off x="7543440" y="4648320"/>
            <a:ext cx="762120" cy="53316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 flipH="1">
            <a:off x="7619760" y="4267080"/>
            <a:ext cx="990360" cy="99072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 flipH="1" flipV="1">
            <a:off x="6324120" y="1066320"/>
            <a:ext cx="2590920" cy="358164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 flipH="1">
            <a:off x="7162920" y="4648320"/>
            <a:ext cx="1752480" cy="106668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FF646-CBAF-4911-A917-819DBFE29F64}" type="slidenum">
              <a:t>10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Audio Dictionary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65" name="" descr=""/>
          <p:cNvPicPr/>
          <p:nvPr/>
        </p:nvPicPr>
        <p:blipFill>
          <a:blip r:embed="rId1"/>
          <a:stretch/>
        </p:blipFill>
        <p:spPr>
          <a:xfrm>
            <a:off x="1808280" y="1424160"/>
            <a:ext cx="6537240" cy="4724280"/>
          </a:xfrm>
          <a:prstGeom prst="rect">
            <a:avLst/>
          </a:prstGeom>
          <a:ln w="0">
            <a:noFill/>
          </a:ln>
        </p:spPr>
      </p:pic>
      <p:sp>
        <p:nvSpPr>
          <p:cNvPr id="166" name=""/>
          <p:cNvSpPr/>
          <p:nvPr/>
        </p:nvSpPr>
        <p:spPr>
          <a:xfrm flipH="1">
            <a:off x="4647960" y="4648320"/>
            <a:ext cx="609480" cy="457200"/>
          </a:xfrm>
          <a:prstGeom prst="line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2"/>
              </a:rPr>
              <a:t>http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4F284-6D1C-406B-946B-65A9F676AA23}" type="slidenum">
              <a:t>11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Audio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69" name="" descr=""/>
          <p:cNvPicPr/>
          <p:nvPr/>
        </p:nvPicPr>
        <p:blipFill>
          <a:blip r:embed="rId1"/>
          <a:srcRect l="0" t="11615" r="0" b="0"/>
          <a:stretch/>
        </p:blipFill>
        <p:spPr>
          <a:xfrm>
            <a:off x="1523880" y="1447920"/>
            <a:ext cx="3146400" cy="2286000"/>
          </a:xfrm>
          <a:prstGeom prst="rect">
            <a:avLst/>
          </a:prstGeom>
          <a:ln w="0">
            <a:noFill/>
          </a:ln>
        </p:spPr>
      </p:pic>
      <p:pic>
        <p:nvPicPr>
          <p:cNvPr id="170" name="" descr=""/>
          <p:cNvPicPr/>
          <p:nvPr/>
        </p:nvPicPr>
        <p:blipFill>
          <a:blip r:embed="rId2"/>
          <a:stretch/>
        </p:blipFill>
        <p:spPr>
          <a:xfrm>
            <a:off x="2438280" y="2133720"/>
            <a:ext cx="3146400" cy="2286000"/>
          </a:xfrm>
          <a:prstGeom prst="rect">
            <a:avLst/>
          </a:prstGeom>
          <a:ln w="0">
            <a:noFill/>
          </a:ln>
        </p:spPr>
      </p:pic>
      <p:pic>
        <p:nvPicPr>
          <p:cNvPr id="171" name="" descr=""/>
          <p:cNvPicPr/>
          <p:nvPr/>
        </p:nvPicPr>
        <p:blipFill>
          <a:blip r:embed="rId3"/>
          <a:stretch/>
        </p:blipFill>
        <p:spPr>
          <a:xfrm>
            <a:off x="3352680" y="2895480"/>
            <a:ext cx="3146400" cy="2286000"/>
          </a:xfrm>
          <a:prstGeom prst="rect">
            <a:avLst/>
          </a:prstGeom>
          <a:ln w="0">
            <a:noFill/>
          </a:ln>
        </p:spPr>
      </p:pic>
      <p:pic>
        <p:nvPicPr>
          <p:cNvPr id="172" name="" descr=""/>
          <p:cNvPicPr/>
          <p:nvPr/>
        </p:nvPicPr>
        <p:blipFill>
          <a:blip r:embed="rId4"/>
          <a:stretch/>
        </p:blipFill>
        <p:spPr>
          <a:xfrm>
            <a:off x="4572000" y="3657600"/>
            <a:ext cx="3341520" cy="2286000"/>
          </a:xfrm>
          <a:prstGeom prst="rect">
            <a:avLst/>
          </a:prstGeom>
          <a:ln w="0">
            <a:noFill/>
          </a:ln>
        </p:spPr>
      </p:pic>
      <p:sp>
        <p:nvSpPr>
          <p:cNvPr id="173" name=""/>
          <p:cNvSpPr/>
          <p:nvPr/>
        </p:nvSpPr>
        <p:spPr>
          <a:xfrm>
            <a:off x="3124080" y="6019920"/>
            <a:ext cx="365760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5"/>
              </a:rPr>
              <a:t>http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6"/>
              </a:rPr>
              <a:t>www.audible.com/nci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5105520" y="1600200"/>
            <a:ext cx="3657600" cy="28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Go to Audible.com/nci web site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5638680" y="2286000"/>
            <a:ext cx="289584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Select lung cancer program </a:t>
            </a:r>
            <a:br>
              <a:rPr sz="1200"/>
            </a:b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to stream or download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6400800" y="2971800"/>
            <a:ext cx="243828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Download to audio file manager on  PC (or PDA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7696080" y="4267080"/>
            <a:ext cx="144792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Listen with media player 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E3596-CA82-420D-BF2D-C4F8F16CB4F9}" type="slidenum">
              <a:t>12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8" name="" descr=""/>
          <p:cNvPicPr/>
          <p:nvPr/>
        </p:nvPicPr>
        <p:blipFill>
          <a:blip r:embed="rId1"/>
          <a:stretch/>
        </p:blipFill>
        <p:spPr>
          <a:xfrm>
            <a:off x="1371600" y="1447920"/>
            <a:ext cx="7467480" cy="4724280"/>
          </a:xfrm>
          <a:prstGeom prst="rect">
            <a:avLst/>
          </a:prstGeom>
          <a:ln w="0">
            <a:noFill/>
          </a:ln>
        </p:spPr>
      </p:pic>
      <p:sp>
        <p:nvSpPr>
          <p:cNvPr id="179" name=""/>
          <p:cNvSpPr/>
          <p:nvPr/>
        </p:nvSpPr>
        <p:spPr>
          <a:xfrm>
            <a:off x="3048120" y="4419720"/>
            <a:ext cx="4114800" cy="609480"/>
          </a:xfrm>
          <a:prstGeom prst="rect">
            <a:avLst/>
          </a:prstGeom>
          <a:solidFill>
            <a:srgbClr val="ffcc99">
              <a:alpha val="39000"/>
            </a:srgbClr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Audio + web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429000" y="3581280"/>
            <a:ext cx="297180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Spoken audio synchronized with highlighted text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 flipH="1" flipV="1">
            <a:off x="5562720" y="4723920"/>
            <a:ext cx="914400" cy="160020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 flipH="1">
            <a:off x="5028840" y="3962520"/>
            <a:ext cx="609480" cy="76176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D23B7-7505-4BC4-A2A8-E61D6F4B75BE}" type="slidenum">
              <a:t>13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Paperback booklet: Cover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1371240" y="1752480"/>
            <a:ext cx="746748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15000"/>
              </a:lnSpc>
              <a:spcBef>
                <a:spcPts val="499"/>
              </a:spcBef>
              <a:buSzPct val="10279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What You Need to Know About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  <a:ea typeface="Arial"/>
              </a:rPr>
              <a:t>™</a:t>
            </a:r>
            <a:r>
              <a:rPr b="1" lang="en-US" sz="2000" spc="-1" strike="noStrike">
                <a:solidFill>
                  <a:srgbClr val="0b3d91"/>
                </a:solidFill>
                <a:latin typeface="Arial"/>
              </a:rPr>
              <a:t> Lung Cancer</a:t>
            </a:r>
            <a:endParaRPr b="1" lang="en-US" sz="2000" spc="-1" strike="noStrike">
              <a:solidFill>
                <a:srgbClr val="0b3d91"/>
              </a:solidFill>
              <a:latin typeface="Arial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2"/>
          <a:stretch/>
        </p:blipFill>
        <p:spPr>
          <a:xfrm>
            <a:off x="3479760" y="2362320"/>
            <a:ext cx="2158920" cy="3429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7" name=""/>
          <p:cNvSpPr/>
          <p:nvPr/>
        </p:nvSpPr>
        <p:spPr>
          <a:xfrm>
            <a:off x="2362320" y="6095880"/>
            <a:ext cx="464796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https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4"/>
              </a:rPr>
              <a:t>cissecure.nci.nih.gov/ncipubs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5"/>
              </a:rPr>
              <a:t>/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631BB-0C77-4DD7-B832-3CB501AEA701}" type="slidenum">
              <a:t>2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Paperback booklet: Contents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09" name="" descr=""/>
          <p:cNvPicPr/>
          <p:nvPr/>
        </p:nvPicPr>
        <p:blipFill>
          <a:blip r:embed="rId1"/>
          <a:stretch/>
        </p:blipFill>
        <p:spPr>
          <a:xfrm>
            <a:off x="1828800" y="1371600"/>
            <a:ext cx="6019920" cy="5103720"/>
          </a:xfrm>
          <a:prstGeom prst="rect">
            <a:avLst/>
          </a:prstGeom>
          <a:ln w="0">
            <a:noFill/>
          </a:ln>
        </p:spPr>
      </p:pic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D32BA-C552-42F5-86C2-B8071D5DF45B}" type="slidenum">
              <a:t>3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Web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11" name="" descr=""/>
          <p:cNvPicPr/>
          <p:nvPr/>
        </p:nvPicPr>
        <p:blipFill>
          <a:blip r:embed="rId1"/>
          <a:stretch/>
        </p:blipFill>
        <p:spPr>
          <a:xfrm>
            <a:off x="1600200" y="1523880"/>
            <a:ext cx="7086600" cy="4483080"/>
          </a:xfrm>
          <a:prstGeom prst="rect">
            <a:avLst/>
          </a:prstGeom>
          <a:ln w="0">
            <a:noFill/>
          </a:ln>
        </p:spPr>
      </p:pic>
      <p:sp>
        <p:nvSpPr>
          <p:cNvPr id="112" name=""/>
          <p:cNvSpPr/>
          <p:nvPr/>
        </p:nvSpPr>
        <p:spPr>
          <a:xfrm>
            <a:off x="2438280" y="6248520"/>
            <a:ext cx="5486400" cy="34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b3d91"/>
                </a:solidFill>
                <a:uFillTx/>
                <a:latin typeface="Arial"/>
                <a:hlinkClick r:id="rId2"/>
              </a:rPr>
              <a:t>http://</a:t>
            </a:r>
            <a:r>
              <a:rPr b="0" lang="en-US" sz="16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www.cancer.gov/cancerinfo/wyntk/lung</a:t>
            </a:r>
            <a:endParaRPr b="0" lang="en-US" sz="1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2D997-C9C5-4018-BE10-3AB8AE2F8E74}" type="slidenum">
              <a:t>4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Table of Contents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14" name="" descr="">
            <a:hlinkClick r:id="rId1"/>
          </p:cNvPr>
          <p:cNvPicPr/>
          <p:nvPr/>
        </p:nvPicPr>
        <p:blipFill>
          <a:blip r:embed="rId2"/>
          <a:stretch/>
        </p:blipFill>
        <p:spPr>
          <a:xfrm>
            <a:off x="1828800" y="1447920"/>
            <a:ext cx="6537240" cy="4724280"/>
          </a:xfrm>
          <a:prstGeom prst="rect">
            <a:avLst/>
          </a:prstGeom>
          <a:ln w="0">
            <a:noFill/>
          </a:ln>
        </p:spPr>
      </p:pic>
      <p:sp>
        <p:nvSpPr>
          <p:cNvPr id="115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http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4"/>
              </a:rPr>
              <a:t>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 flipH="1">
            <a:off x="7543440" y="4648320"/>
            <a:ext cx="762120" cy="53316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flipH="1">
            <a:off x="7619760" y="4267080"/>
            <a:ext cx="990360" cy="99072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118" name=""/>
          <p:cNvGrpSpPr/>
          <p:nvPr/>
        </p:nvGrpSpPr>
        <p:grpSpPr>
          <a:xfrm>
            <a:off x="7391160" y="1066320"/>
            <a:ext cx="1524240" cy="4191480"/>
            <a:chOff x="7391160" y="1066320"/>
            <a:chExt cx="1524240" cy="4191480"/>
          </a:xfrm>
        </p:grpSpPr>
        <p:sp>
          <p:nvSpPr>
            <p:cNvPr id="119" name=""/>
            <p:cNvSpPr/>
            <p:nvPr/>
          </p:nvSpPr>
          <p:spPr>
            <a:xfrm flipH="1" flipV="1">
              <a:off x="7391160" y="1066320"/>
              <a:ext cx="1523880" cy="35816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7920" rIns="97920" tIns="48960" bIns="48960" anchor="ctr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 flipH="1">
              <a:off x="7543800" y="4648320"/>
              <a:ext cx="1371600" cy="609480"/>
            </a:xfrm>
            <a:prstGeom prst="line">
              <a:avLst/>
            </a:prstGeom>
            <a:ln w="93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7920" rIns="97920" tIns="48960" bIns="48960" anchor="ctr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121" name=""/>
          <p:cNvSpPr/>
          <p:nvPr/>
        </p:nvSpPr>
        <p:spPr>
          <a:xfrm>
            <a:off x="5410080" y="2438280"/>
            <a:ext cx="1371600" cy="129564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3048120" y="2286000"/>
            <a:ext cx="251460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Can select specific topic links  </a:t>
            </a:r>
            <a:br>
              <a:rPr sz="1200"/>
            </a:b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or proceed linearly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4952880" y="2666880"/>
            <a:ext cx="838440" cy="312444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970B0-CD33-4E8A-B1CF-176004AEAED5}" type="slidenum">
              <a:t>5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View Page Outline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1805040" y="1424160"/>
            <a:ext cx="6537240" cy="4724280"/>
          </a:xfrm>
          <a:prstGeom prst="rect">
            <a:avLst/>
          </a:prstGeom>
          <a:ln w="0">
            <a:noFill/>
          </a:ln>
        </p:spPr>
      </p:pic>
      <p:sp>
        <p:nvSpPr>
          <p:cNvPr id="126" name=""/>
          <p:cNvSpPr/>
          <p:nvPr/>
        </p:nvSpPr>
        <p:spPr>
          <a:xfrm flipH="1" flipV="1">
            <a:off x="7391160" y="1066320"/>
            <a:ext cx="1523880" cy="358164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flipH="1">
            <a:off x="7543800" y="4648320"/>
            <a:ext cx="1371600" cy="76176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2"/>
              </a:rPr>
              <a:t>http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5334120" y="2666880"/>
            <a:ext cx="838080" cy="30492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3809880" y="2362320"/>
            <a:ext cx="198144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Links to audio dictionary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 flipH="1" flipV="1">
            <a:off x="7238520" y="2819520"/>
            <a:ext cx="1676520" cy="18288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FD004-38D2-451C-875E-AFC6F625B782}" type="slidenum">
              <a:t>6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View Audio Text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1809720" y="1419120"/>
            <a:ext cx="6537240" cy="472464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 flipH="1" flipV="1">
            <a:off x="7391160" y="1218960"/>
            <a:ext cx="1447560" cy="34290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 flipH="1">
            <a:off x="7467480" y="4648320"/>
            <a:ext cx="1371600" cy="9144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2"/>
              </a:rPr>
              <a:t>http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flipH="1" flipV="1">
            <a:off x="7695720" y="4266720"/>
            <a:ext cx="1219320" cy="3812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5029200" y="2666880"/>
            <a:ext cx="1676520" cy="6858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2438280" y="2362320"/>
            <a:ext cx="266724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b3d91"/>
                </a:solidFill>
                <a:latin typeface="Arial"/>
              </a:rPr>
              <a:t>Spoken audio text is highlighted and synchronized with animation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6CB6D-5FD6-4B8B-BB31-28E6C811ACC8}" type="slidenum">
              <a:t>7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Select Print Function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41" name="" descr=""/>
          <p:cNvPicPr/>
          <p:nvPr/>
        </p:nvPicPr>
        <p:blipFill>
          <a:blip r:embed="rId1"/>
          <a:stretch/>
        </p:blipFill>
        <p:spPr>
          <a:xfrm>
            <a:off x="1828800" y="1447920"/>
            <a:ext cx="6537240" cy="4724280"/>
          </a:xfrm>
          <a:prstGeom prst="rect">
            <a:avLst/>
          </a:prstGeom>
          <a:ln w="0">
            <a:noFill/>
          </a:ln>
        </p:spPr>
      </p:pic>
      <p:sp>
        <p:nvSpPr>
          <p:cNvPr id="142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900" spc="-1" strike="noStrike">
                <a:solidFill>
                  <a:srgbClr val="0b3d91"/>
                </a:solidFill>
                <a:latin typeface="Arial"/>
              </a:rPr>
              <a:t>http://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 flipH="1">
            <a:off x="7543440" y="4648320"/>
            <a:ext cx="762120" cy="53316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 flipH="1">
            <a:off x="7619760" y="4267080"/>
            <a:ext cx="990360" cy="99072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 flipH="1" flipV="1">
            <a:off x="6324120" y="1066320"/>
            <a:ext cx="2590920" cy="358164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 flipH="1">
            <a:off x="6553080" y="4648320"/>
            <a:ext cx="2362320" cy="11430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D2EF9A-DF02-442C-A818-62F014734CF4}" type="slidenum">
              <a:t>8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aeaea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1219320" y="533520"/>
            <a:ext cx="7772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7c2022"/>
                </a:solidFill>
                <a:latin typeface="Arial"/>
              </a:rPr>
              <a:t>Flash</a:t>
            </a:r>
            <a:r>
              <a:rPr b="1" lang="en-US" sz="2800" spc="-1" strike="noStrike">
                <a:solidFill>
                  <a:srgbClr val="7c2022"/>
                </a:solidFill>
                <a:latin typeface="Arial"/>
                <a:ea typeface="Arial"/>
              </a:rPr>
              <a:t>™: Print Options</a:t>
            </a:r>
            <a:endParaRPr b="1" lang="en-US" sz="2800" spc="-1" strike="noStrike">
              <a:solidFill>
                <a:srgbClr val="7c2022"/>
              </a:solidFill>
              <a:latin typeface="Arial"/>
            </a:endParaRPr>
          </a:p>
        </p:txBody>
      </p:sp>
      <p:pic>
        <p:nvPicPr>
          <p:cNvPr id="148" name="" descr=""/>
          <p:cNvPicPr/>
          <p:nvPr/>
        </p:nvPicPr>
        <p:blipFill>
          <a:blip r:embed="rId1"/>
          <a:stretch/>
        </p:blipFill>
        <p:spPr>
          <a:xfrm>
            <a:off x="1808280" y="1424160"/>
            <a:ext cx="6537240" cy="4724280"/>
          </a:xfrm>
          <a:prstGeom prst="rect">
            <a:avLst/>
          </a:prstGeom>
          <a:ln w="0">
            <a:noFill/>
          </a:ln>
        </p:spPr>
      </p:pic>
      <p:sp>
        <p:nvSpPr>
          <p:cNvPr id="149" name=""/>
          <p:cNvSpPr/>
          <p:nvPr/>
        </p:nvSpPr>
        <p:spPr>
          <a:xfrm flipH="1">
            <a:off x="4876560" y="4038480"/>
            <a:ext cx="990360" cy="76212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8763120" y="2590920"/>
            <a:ext cx="0" cy="114300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3809880" y="4267080"/>
            <a:ext cx="457200" cy="45720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2590920" y="6248520"/>
            <a:ext cx="56386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spAutoFit/>
          </a:bodyPr>
          <a:p>
            <a:pPr algn="ctr">
              <a:lnSpc>
                <a:spcPct val="100000"/>
              </a:lnSpc>
              <a:spcBef>
                <a:spcPts val="11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2"/>
              </a:rPr>
              <a:t>http://</a:t>
            </a:r>
            <a:r>
              <a:rPr b="0" lang="en-US" sz="1900" spc="-1" strike="noStrike" u="sng">
                <a:solidFill>
                  <a:srgbClr val="0b3d91"/>
                </a:solidFill>
                <a:uFillTx/>
                <a:latin typeface="Arial"/>
                <a:hlinkClick r:id="rId3"/>
              </a:rPr>
              <a:t>www.medicomdigital.com/nci/lungcancer</a:t>
            </a:r>
            <a:endParaRPr b="0" lang="en-US" sz="19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2286000" y="3048120"/>
            <a:ext cx="1600200" cy="1447560"/>
          </a:xfrm>
          <a:prstGeom prst="ellips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1523880" y="838080"/>
            <a:ext cx="1524240" cy="533520"/>
          </a:xfrm>
          <a:prstGeom prst="ellips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1600200" y="838080"/>
            <a:ext cx="1752480" cy="457200"/>
          </a:xfrm>
          <a:prstGeom prst="ellips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1905120" y="2743200"/>
            <a:ext cx="2057400" cy="175248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Communication Technologies Branch, NCI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7D58C-F6C1-4E0E-876F-D56A76F45A7C}" type="slidenum">
              <a:t>9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>June 26, 2003</a:t>
            </a: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9-11T12:16:20Z</dcterms:created>
  <dc:creator>NCI</dc:creator>
  <dc:description/>
  <cp:keywords>paper audio web Flash</cp:keywords>
  <dc:language>en-US</dc:language>
  <cp:lastModifiedBy>Registered User</cp:lastModifiedBy>
  <cp:lastPrinted>2001-05-15T15:10:47Z</cp:lastPrinted>
  <dcterms:modified xsi:type="dcterms:W3CDTF">2003-06-26T15:22:39Z</dcterms:modified>
  <cp:revision>681</cp:revision>
  <dc:subject/>
  <dc:title>Demo of 5 Media Formats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793671406</vt:r8>
  </property>
  <property fmtid="{D5CDD505-2E9C-101B-9397-08002B2CF9AE}" pid="3" name="_AuthorEmail">
    <vt:lpwstr>geysenba@uhnres.utoronto.ca</vt:lpwstr>
  </property>
  <property fmtid="{D5CDD505-2E9C-101B-9397-08002B2CF9AE}" pid="4" name="_AuthorEmailDisplayName">
    <vt:lpwstr>Dr. Gunther Eysenbach</vt:lpwstr>
  </property>
  <property fmtid="{D5CDD505-2E9C-101B-9397-08002B2CF9AE}" pid="5" name="_EmailSubject">
    <vt:lpwstr>2003051301</vt:lpwstr>
  </property>
  <property fmtid="{D5CDD505-2E9C-101B-9397-08002B2CF9AE}" pid="6" name="_PreviousAdHocReviewCycleID">
    <vt:r8>-312041831</vt:r8>
  </property>
</Properties>
</file>